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1" r:id="rId2"/>
    <p:sldId id="271" r:id="rId3"/>
    <p:sldId id="263" r:id="rId4"/>
    <p:sldId id="264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49"/>
    <p:restoredTop sz="94666"/>
  </p:normalViewPr>
  <p:slideViewPr>
    <p:cSldViewPr snapToGrid="0" snapToObjects="1">
      <p:cViewPr varScale="1">
        <p:scale>
          <a:sx n="71" d="100"/>
          <a:sy n="71" d="100"/>
        </p:scale>
        <p:origin x="2320" y="1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232880-3DD3-7840-98CB-78F396551FE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E74612-4CA1-E040-8D61-CA4D08F8F1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276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E74612-4CA1-E040-8D61-CA4D08F8F1F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1571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E74612-4CA1-E040-8D61-CA4D08F8F1F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6067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0662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449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4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7" y="396704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155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579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663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7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2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087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28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782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133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10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563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412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E1C75-A34C-E344-AFCF-529F90229791}" type="datetimeFigureOut">
              <a:rPr lang="en-US" smtClean="0"/>
              <a:t>11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AA76B-9404-5D4C-8002-126ACCC2CC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494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DC1501F-4AA9-3F44-970C-09379DD6E338}"/>
              </a:ext>
            </a:extLst>
          </p:cNvPr>
          <p:cNvSpPr/>
          <p:nvPr/>
        </p:nvSpPr>
        <p:spPr>
          <a:xfrm>
            <a:off x="258528" y="2081743"/>
            <a:ext cx="6367126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ig. S1. Compartment normalized score by chromosome size; Red: ES cell, green: Pro-B cell, and blue: B-cell lymphoma. Normalization scores are calculated by dividing the sum of compartments in each chromosome by its chromosome size. X axis represent chromosomes and Y axis represents the normalized scores.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77C9AA3-AC58-284F-95E6-7C851BA8BB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528" y="489961"/>
            <a:ext cx="6367126" cy="1591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574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DB4366D6-D86F-F143-982C-F10B92155366}"/>
              </a:ext>
            </a:extLst>
          </p:cNvPr>
          <p:cNvSpPr txBox="1"/>
          <p:nvPr/>
        </p:nvSpPr>
        <p:spPr>
          <a:xfrm>
            <a:off x="240797" y="171015"/>
            <a:ext cx="295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240DFB-5001-524E-8F1B-32B54071DCC2}"/>
              </a:ext>
            </a:extLst>
          </p:cNvPr>
          <p:cNvSpPr txBox="1"/>
          <p:nvPr/>
        </p:nvSpPr>
        <p:spPr>
          <a:xfrm>
            <a:off x="240797" y="3221100"/>
            <a:ext cx="30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BFECACB-943D-D146-B950-690109BC454D}"/>
              </a:ext>
            </a:extLst>
          </p:cNvPr>
          <p:cNvSpPr/>
          <p:nvPr/>
        </p:nvSpPr>
        <p:spPr>
          <a:xfrm>
            <a:off x="2889196" y="355681"/>
            <a:ext cx="3628599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g. S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file of gene expression in compartment reorganization in comparison with random genes from stable profiles (both in A or both in B).  (a) ES cell, B cell, and random genes. (b) ES cell, lymphoma, and random genes. (c) Pro-B cell, lymphoma, and random genes. Random genes are sets of n genes arbitrary taken from merged stable region genes.</a:t>
            </a:r>
            <a:endParaRPr lang="en-US" sz="11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868E125-EB71-2F4C-ADB8-0D3CED87D5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420" y="3221100"/>
            <a:ext cx="2044545" cy="266803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CA8AB5B-AC28-4D46-84F3-4F770F04BF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726" y="171015"/>
            <a:ext cx="2046239" cy="270797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B9AB4A7-05D3-B34A-9114-771BDADC95E9}"/>
              </a:ext>
            </a:extLst>
          </p:cNvPr>
          <p:cNvSpPr txBox="1"/>
          <p:nvPr/>
        </p:nvSpPr>
        <p:spPr>
          <a:xfrm>
            <a:off x="240797" y="623124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385015B-82E7-824E-AF70-5B01D27BB6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0726" y="6231248"/>
            <a:ext cx="2054010" cy="2715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64855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848BC3D-9B55-E046-AC7B-2E6F55ED68B3}"/>
              </a:ext>
            </a:extLst>
          </p:cNvPr>
          <p:cNvSpPr/>
          <p:nvPr/>
        </p:nvSpPr>
        <p:spPr>
          <a:xfrm>
            <a:off x="242450" y="2337256"/>
            <a:ext cx="628056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ig. S3: Normalized TAD number per chromosome size performed in ES cell (red line), B cell (green), and B cell lymphoma (blue). Normalization scores are calculated by dividing the sum of compartments in each chromosome by its chromosome size. X axis represent chromosomes and Y axis represents the normalized scores. </a:t>
            </a:r>
            <a:endParaRPr lang="en-US" sz="11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FAE1A64-DC80-C84F-8281-3BC8B8FCB9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442" y="239324"/>
            <a:ext cx="6080568" cy="2026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91170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36CC0F4-EC7A-074B-B706-03B49F5C1993}"/>
              </a:ext>
            </a:extLst>
          </p:cNvPr>
          <p:cNvSpPr/>
          <p:nvPr/>
        </p:nvSpPr>
        <p:spPr>
          <a:xfrm>
            <a:off x="335404" y="4780579"/>
            <a:ext cx="596046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ig. S4: Heatmap of set of genes known to be involved </a:t>
            </a:r>
            <a:r>
              <a:rPr lang="en-US" sz="110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in B-cell </a:t>
            </a: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ate and B-cell lymphoma. Values are in log</a:t>
            </a:r>
            <a:r>
              <a:rPr lang="en-US" sz="1100" baseline="-250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10</a:t>
            </a:r>
            <a:r>
              <a:rPr lang="en-US" sz="1100" dirty="0"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(TPM) with respective compartment classification.</a:t>
            </a:r>
            <a:endParaRPr lang="en-US" sz="11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4F7EE0B-59DA-784A-A376-8262669637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2554" y="594194"/>
            <a:ext cx="4203700" cy="386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9117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57</TotalTime>
  <Words>234</Words>
  <Application>Microsoft Macintosh PowerPoint</Application>
  <PresentationFormat>A4 Paper (210x297 mm)</PresentationFormat>
  <Paragraphs>9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MS Mincho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ijy Nagai</dc:creator>
  <cp:lastModifiedBy>NAGAI　LUIS AUGUSTO EIJY</cp:lastModifiedBy>
  <cp:revision>58</cp:revision>
  <dcterms:created xsi:type="dcterms:W3CDTF">2018-05-28T06:03:43Z</dcterms:created>
  <dcterms:modified xsi:type="dcterms:W3CDTF">2018-11-10T14:27:09Z</dcterms:modified>
</cp:coreProperties>
</file>